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32394D-2F67-4B37-BF5E-6CFC920C5D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BD1372-4F51-4576-BDDB-19F7F78AE5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3AC2B-8351-4540-A4BB-4C8C533AE2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AF6AB-3117-421D-8EE2-53A2EE8293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5A5FA-3A2F-49DA-8EAA-6D61A91D32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56F264-4630-4448-BD42-A59CFC9A89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B9023E-DE3E-40CE-940E-6CD163025C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83F5FF-15B8-48FB-9502-3A5637EC95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F03605-3660-4416-9C60-899DEA356E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71C00-DE81-4625-99A4-867899CF88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C13751-8A46-401C-A2B3-B8436A7960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BB09A6-288D-401E-9CC5-B37077D13B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419E4E-2DA8-452D-A832-0F5B4025FBD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34080" y="5384880"/>
            <a:ext cx="6399360" cy="3516120"/>
            <a:chOff x="334080" y="5384880"/>
            <a:chExt cx="6399360" cy="3516120"/>
          </a:xfrm>
        </p:grpSpPr>
        <p:sp>
          <p:nvSpPr>
            <p:cNvPr id="42" name=""/>
            <p:cNvSpPr/>
            <p:nvPr/>
          </p:nvSpPr>
          <p:spPr>
            <a:xfrm>
              <a:off x="334080" y="6949800"/>
              <a:ext cx="38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5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510840" y="5994360"/>
              <a:ext cx="6054480" cy="431280"/>
            </a:xfrm>
            <a:prstGeom prst="rect">
              <a:avLst/>
            </a:prstGeom>
            <a:gradFill rotWithShape="0">
              <a:gsLst>
                <a:gs pos="0">
                  <a:srgbClr val="808080"/>
                </a:gs>
                <a:gs pos="100000">
                  <a:srgbClr val="ffffff"/>
                </a:gs>
              </a:gsLst>
              <a:path path="rect">
                <a:fillToRect l="50000" t="50000" r="50000" b="50000"/>
              </a:path>
            </a:gradFill>
            <a:ln w="2556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510840" y="6440400"/>
              <a:ext cx="69480" cy="502920"/>
            </a:xfrm>
            <a:prstGeom prst="upArrow">
              <a:avLst>
                <a:gd name="adj1" fmla="val 50000"/>
                <a:gd name="adj2" fmla="val 180959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871200" y="6440400"/>
              <a:ext cx="69480" cy="502920"/>
            </a:xfrm>
            <a:prstGeom prst="upArrow">
              <a:avLst>
                <a:gd name="adj1" fmla="val 50000"/>
                <a:gd name="adj2" fmla="val 180959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231560" y="6440400"/>
              <a:ext cx="69480" cy="502920"/>
            </a:xfrm>
            <a:prstGeom prst="upArrow">
              <a:avLst>
                <a:gd name="adj1" fmla="val 50000"/>
                <a:gd name="adj2" fmla="val 180959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526840" y="6440400"/>
              <a:ext cx="69480" cy="502920"/>
            </a:xfrm>
            <a:prstGeom prst="upArrow">
              <a:avLst>
                <a:gd name="adj1" fmla="val 50000"/>
                <a:gd name="adj2" fmla="val 180959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031920" y="6440400"/>
              <a:ext cx="69480" cy="502920"/>
            </a:xfrm>
            <a:prstGeom prst="upArrow">
              <a:avLst>
                <a:gd name="adj1" fmla="val 50000"/>
                <a:gd name="adj2" fmla="val 180959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624280" y="6440400"/>
              <a:ext cx="69480" cy="502920"/>
            </a:xfrm>
            <a:prstGeom prst="upArrow">
              <a:avLst>
                <a:gd name="adj1" fmla="val 50000"/>
                <a:gd name="adj2" fmla="val 180959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487920" y="6440400"/>
              <a:ext cx="69480" cy="502920"/>
            </a:xfrm>
            <a:prstGeom prst="upArrow">
              <a:avLst>
                <a:gd name="adj1" fmla="val 50000"/>
                <a:gd name="adj2" fmla="val 180959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73560" y="6949800"/>
              <a:ext cx="45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5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054080" y="694980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355840" y="694980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3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879640" y="694980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5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406840" y="6949800"/>
              <a:ext cx="459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3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6273720" y="6949800"/>
              <a:ext cx="459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8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937520" y="7973640"/>
              <a:ext cx="108288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Lafora bodi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62600" y="8624520"/>
              <a:ext cx="267084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Ground-glass inclusions PAS positiv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454120" y="7304040"/>
              <a:ext cx="121680" cy="502560"/>
            </a:xfrm>
            <a:prstGeom prst="upArrow">
              <a:avLst>
                <a:gd name="adj1" fmla="val 50000"/>
                <a:gd name="adj2" fmla="val 103254"/>
              </a:avLst>
            </a:prstGeom>
            <a:solidFill>
              <a:srgbClr val="000000"/>
            </a:solidFill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158480" y="7304040"/>
              <a:ext cx="120240" cy="1152000"/>
            </a:xfrm>
            <a:prstGeom prst="upArrow">
              <a:avLst>
                <a:gd name="adj1" fmla="val 50000"/>
                <a:gd name="adj2" fmla="val 239521"/>
              </a:avLst>
            </a:prstGeom>
            <a:solidFill>
              <a:srgbClr val="000000"/>
            </a:solidFill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42800" y="5384880"/>
              <a:ext cx="221688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Molecular and cellular chang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rot="5400000">
              <a:off x="1469520" y="5121000"/>
              <a:ext cx="215640" cy="1269360"/>
            </a:xfrm>
            <a:custGeom>
              <a:avLst/>
              <a:gdLst>
                <a:gd name="textAreaLeft" fmla="*/ 137880 w 215640"/>
                <a:gd name="textAreaRight" fmla="*/ 216000 w 215640"/>
                <a:gd name="textAreaTop" fmla="*/ 32760 h 1269360"/>
                <a:gd name="textAreaBottom" fmla="*/ 1236600 h 1269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"/>
          <p:cNvGrpSpPr/>
          <p:nvPr/>
        </p:nvGrpSpPr>
        <p:grpSpPr>
          <a:xfrm>
            <a:off x="969840" y="560520"/>
            <a:ext cx="4835160" cy="4343040"/>
            <a:chOff x="969840" y="560520"/>
            <a:chExt cx="4835160" cy="4343040"/>
          </a:xfrm>
        </p:grpSpPr>
        <p:sp>
          <p:nvSpPr>
            <p:cNvPr id="64" name=""/>
            <p:cNvSpPr/>
            <p:nvPr/>
          </p:nvSpPr>
          <p:spPr>
            <a:xfrm>
              <a:off x="1717560" y="2282760"/>
              <a:ext cx="253800" cy="16203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319120" y="1041120"/>
              <a:ext cx="254160" cy="2862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922480" y="3236760"/>
              <a:ext cx="239760" cy="6663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511440" y="2963880"/>
              <a:ext cx="253800" cy="9392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113000" y="3827160"/>
              <a:ext cx="254160" cy="759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714560" y="2873160"/>
              <a:ext cx="255600" cy="10299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636560" y="3616200"/>
              <a:ext cx="401760" cy="286920"/>
            </a:xfrm>
            <a:prstGeom prst="rect">
              <a:avLst/>
            </a:prstGeom>
            <a:solidFill>
              <a:srgbClr val="bbe0e3">
                <a:alpha val="5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239920" y="1374480"/>
              <a:ext cx="401400" cy="2528640"/>
            </a:xfrm>
            <a:prstGeom prst="rect">
              <a:avLst/>
            </a:prstGeom>
            <a:solidFill>
              <a:srgbClr val="bbe0e3">
                <a:alpha val="5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841480" y="3600360"/>
              <a:ext cx="387360" cy="302760"/>
            </a:xfrm>
            <a:prstGeom prst="rect">
              <a:avLst/>
            </a:prstGeom>
            <a:solidFill>
              <a:srgbClr val="bbe0e3">
                <a:alpha val="5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430440" y="3616200"/>
              <a:ext cx="401760" cy="286920"/>
            </a:xfrm>
            <a:prstGeom prst="rect">
              <a:avLst/>
            </a:prstGeom>
            <a:solidFill>
              <a:srgbClr val="bbe0e3">
                <a:alpha val="5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032000" y="3887640"/>
              <a:ext cx="401760" cy="15480"/>
            </a:xfrm>
            <a:prstGeom prst="rect">
              <a:avLst/>
            </a:prstGeom>
            <a:solidFill>
              <a:srgbClr val="9933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635360" y="3116160"/>
              <a:ext cx="401760" cy="786960"/>
            </a:xfrm>
            <a:prstGeom prst="rect">
              <a:avLst/>
            </a:prstGeom>
            <a:solidFill>
              <a:srgbClr val="bbe0e3">
                <a:alpha val="5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542960" y="752400"/>
              <a:ext cx="3240" cy="3150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488960" y="3903480"/>
              <a:ext cx="540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488960" y="3449520"/>
              <a:ext cx="540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488960" y="3009600"/>
              <a:ext cx="5400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488960" y="2555640"/>
              <a:ext cx="540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488960" y="2100240"/>
              <a:ext cx="5400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488960" y="1645920"/>
              <a:ext cx="5400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488960" y="1207800"/>
              <a:ext cx="540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488960" y="752400"/>
              <a:ext cx="5400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546200" y="3911400"/>
              <a:ext cx="37098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1542960" y="3903120"/>
              <a:ext cx="3240" cy="6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2146320" y="3903120"/>
              <a:ext cx="1440" cy="6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2747880" y="3903120"/>
              <a:ext cx="1440" cy="6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V="1">
              <a:off x="3336840" y="3903120"/>
              <a:ext cx="1440" cy="6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V="1">
              <a:off x="3938400" y="3903120"/>
              <a:ext cx="3240" cy="6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V="1">
              <a:off x="4541760" y="3903120"/>
              <a:ext cx="1440" cy="6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flipV="1">
              <a:off x="5143320" y="3903120"/>
              <a:ext cx="3240" cy="6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312200" y="378288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312200" y="33271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312200" y="288900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312200" y="243360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312200" y="197928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312200" y="15253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312200" y="108576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312200" y="63180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1" name=""/>
            <p:cNvGrpSpPr/>
            <p:nvPr/>
          </p:nvGrpSpPr>
          <p:grpSpPr>
            <a:xfrm>
              <a:off x="5146560" y="631800"/>
              <a:ext cx="658440" cy="3333600"/>
              <a:chOff x="5146560" y="631800"/>
              <a:chExt cx="658440" cy="3333600"/>
            </a:xfrm>
          </p:grpSpPr>
          <p:sp>
            <p:nvSpPr>
              <p:cNvPr id="102" name=""/>
              <p:cNvSpPr/>
              <p:nvPr/>
            </p:nvSpPr>
            <p:spPr>
              <a:xfrm flipV="1">
                <a:off x="5198760" y="3902760"/>
                <a:ext cx="3240" cy="60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5198760" y="752040"/>
                <a:ext cx="3240" cy="3150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5146560" y="3903120"/>
                <a:ext cx="1062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5146560" y="3266640"/>
                <a:ext cx="106200" cy="2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5146560" y="2646000"/>
                <a:ext cx="106200" cy="2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280" bIns="-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5146560" y="2009160"/>
                <a:ext cx="106200" cy="2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5146560" y="1388520"/>
                <a:ext cx="106200" cy="2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5146560" y="752040"/>
                <a:ext cx="106200" cy="2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5301720" y="378252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5301720" y="314604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5301720" y="252504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5301720" y="188856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1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5301720" y="126792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5301720" y="63180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2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rot="5400000">
                <a:off x="4527720" y="2395080"/>
                <a:ext cx="2277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Ground-glass inclusions/100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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m</a:t>
                </a:r>
                <a:r>
                  <a:rPr b="1" lang="en-US" sz="1200" spc="-1" strike="noStrike" baseline="30000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7" name=""/>
            <p:cNvSpPr/>
            <p:nvPr/>
          </p:nvSpPr>
          <p:spPr>
            <a:xfrm rot="16200000">
              <a:off x="259560" y="2113200"/>
              <a:ext cx="169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Lafora bodies/</a:t>
              </a: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m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</a:rPr>
                <a:t>2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 Unicode MS"/>
                </a:rPr>
                <a:t>×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</a:rPr>
                <a:t>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 rot="3100200">
              <a:off x="1624680" y="4353480"/>
              <a:ext cx="1024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erebral corte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rot="3102600">
              <a:off x="2260080" y="4303800"/>
              <a:ext cx="90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Hippocamp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rot="3108600">
              <a:off x="2876400" y="4288680"/>
              <a:ext cx="870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Basal gangli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rot="3096600">
              <a:off x="3467520" y="4205880"/>
              <a:ext cx="654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Thalam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rot="3102600">
              <a:off x="4049280" y="4322880"/>
              <a:ext cx="95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Hypothalam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rot="3102000">
              <a:off x="4683600" y="4248720"/>
              <a:ext cx="761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erebellu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4" name=""/>
            <p:cNvGrpSpPr/>
            <p:nvPr/>
          </p:nvGrpSpPr>
          <p:grpSpPr>
            <a:xfrm>
              <a:off x="3319200" y="560520"/>
              <a:ext cx="1702440" cy="533160"/>
              <a:chOff x="3319200" y="560520"/>
              <a:chExt cx="1702440" cy="533160"/>
            </a:xfrm>
          </p:grpSpPr>
          <p:sp>
            <p:nvSpPr>
              <p:cNvPr id="125" name=""/>
              <p:cNvSpPr/>
              <p:nvPr/>
            </p:nvSpPr>
            <p:spPr>
              <a:xfrm>
                <a:off x="3319200" y="847440"/>
                <a:ext cx="243000" cy="215640"/>
              </a:xfrm>
              <a:prstGeom prst="rect">
                <a:avLst/>
              </a:prstGeom>
              <a:solidFill>
                <a:srgbClr val="bbe0e3">
                  <a:alpha val="50000"/>
                </a:srgbClr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319200" y="560520"/>
                <a:ext cx="243000" cy="21564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3490200" y="560520"/>
                <a:ext cx="94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afora bodie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3490560" y="847440"/>
                <a:ext cx="1531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Ground-glass inclusion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29" name=""/>
          <p:cNvSpPr/>
          <p:nvPr/>
        </p:nvSpPr>
        <p:spPr>
          <a:xfrm>
            <a:off x="2521080" y="9502920"/>
            <a:ext cx="184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2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43360" y="318960"/>
            <a:ext cx="30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60640" y="4924440"/>
            <a:ext cx="30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1T13:28:43Z</dcterms:created>
  <dc:creator>Consellería de Sanidade-Servizo Galego de Saúde</dc:creator>
  <dc:description/>
  <dc:language>en-US</dc:language>
  <cp:lastModifiedBy>Consellería de Sanidade-Servizo Galego de Saúde</cp:lastModifiedBy>
  <dcterms:modified xsi:type="dcterms:W3CDTF">2013-11-27T11:46:45Z</dcterms:modified>
  <cp:revision>68</cp:revision>
  <dc:subject/>
  <dc:title>Diapositiva 1</dc:title>
</cp:coreProperties>
</file>